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1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006AB1-1706-46B6-BE78-281FF3E78B6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024C95-5186-4770-9C1C-B3B34DDA641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3504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014303-1DE8-F545-996F-8D127D53078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1975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74BB5D-BBEA-5422-981C-7D65453048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04D5065-C56D-E3F8-C90A-17022D588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8F85FDC-367C-716D-1839-738DEF1B2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8D8EB86-4C77-AFD3-84A4-70FE048F8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A96D8E-8112-06F6-84E9-A384E13FD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0741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93B7A5-212D-15E2-16E0-0AC16EA4E7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63C2A46-017A-B6AC-E485-404AA43102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23D5488-FBDC-3E9C-4DD8-8153D19AA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61E2D22-CF42-C6A4-950F-139ACFA27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3006866-7AC8-75C6-80DF-ADDF8CE44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7607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879B2CC-8A4C-1733-6D7B-62A9B22DCB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2D195F6-5AB9-DB42-DEC8-8FA0F55609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AEAB691-9329-42FF-096C-7C4949A3A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125EC18-5AEA-264B-71BC-33AC696D2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75F46FF-2649-449A-F596-F24BF5D30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0412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D784AC-08DD-F6AA-627C-350776C25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1319AF1-2150-318A-5F41-A877478FD5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D41E2CC-C367-2738-2EE6-D63B8B3BD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095C9E-E573-A65B-D4ED-F0A35B614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20DB1E4-F987-7846-121A-518D3C30F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095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B50837-0C0E-2771-8D5F-732BDB7FF5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5FDBCCF-F7D0-9868-ED37-E5EEBADFF9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DC6FF4E-468A-74A1-698B-B2BCF71F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5ED15D-086C-0044-271F-6343C7C20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D2EC78-E101-1F09-3BB9-3D4FC1EAD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58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E87EB1-93C6-8870-F3A9-53ED6E6D60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81666BE-7FF0-A8D6-EFAB-3C2A1F87A9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51195E3-62A2-6CF8-CEDA-8368033B0E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2432603-DBC7-5C4E-AEA0-315137C42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55C41A5-18F0-8846-FA8D-7E27149DB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81286D4-871C-2BD3-6E9D-0F134CBD2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1751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2FB7B9-BBCB-1EA0-4521-1128C23E3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9A1513E-4592-F3BC-6F56-B3629C427D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2E7E429-0CA5-0978-BA33-CFA4A293D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7B5D7A9-B2FA-9D64-B658-E0C7026860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5C19BB1-2EB0-F048-233E-63BB1C5FB6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FCF8926-6A68-DB5C-43F0-30E3FE866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8036315-6E7A-D968-4560-FD35C87FC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DDBC1EF-D5DA-AD75-2FBF-B3C7D9FCD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0443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F1DDB5D-6C37-59D1-87F0-421E037DF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61FD242-5E98-ED5E-16CC-D2603F4BC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8D1CEAD-4727-3FCF-5350-F3A70C924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312CE46-1EC1-B77A-A140-12A730ACA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277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D6AA14A-CD66-82C1-54CB-91501C469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1F26831-8182-996B-AA7F-28E6EF709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FC5A30B-C5FE-9CF3-84E2-BA37DFF44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4387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42161E-8EF8-7BDC-2BB6-3EF124C9F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4E0E769-C7AC-B1C5-7FF9-8972914180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65B71A8-5DCD-88DC-DADE-89D55DCD5D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34F1874-B8A0-4D55-4C1D-E52F01F90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116BC4C-BDEB-2A2D-0911-E7A33DF5C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2B9299F-4AE4-533D-AE05-552AF65F0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615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727495-E808-4A85-3D55-4258CFC22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BBD1A99-64F1-EF4A-024D-76238977A6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529BAA-3824-F3AD-E543-192241BBEA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E9563EC-E571-BFEB-A560-9B6453373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EC31E52-921C-5BD2-62D0-1FCB9CE2A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AB92E2E-A422-A8C8-E92C-7FC08A276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8416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835F11F-AF74-1DD3-268C-A67B0723E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78527EE-07D1-7237-7A8A-CAD20B6131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0CFDE1-66EA-64CC-60F6-F535C7FB99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EBC83-F0AF-4A29-ADBB-A46E38F32C9A}" type="datetimeFigureOut">
              <a:rPr lang="es-ES" smtClean="0"/>
              <a:t>12/1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F0A799-31F3-A992-44C4-FD543BDBB9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1303D86-40B3-FAE4-098D-CC0AF948A3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BC6E2-E48D-4855-89D8-CE6E5194E69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69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mp"/><Relationship Id="rId13" Type="http://schemas.openxmlformats.org/officeDocument/2006/relationships/image" Target="../media/image11.tmp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mp"/><Relationship Id="rId11" Type="http://schemas.openxmlformats.org/officeDocument/2006/relationships/image" Target="../media/image9.tmp"/><Relationship Id="rId5" Type="http://schemas.openxmlformats.org/officeDocument/2006/relationships/image" Target="../media/image3.tmp"/><Relationship Id="rId15" Type="http://schemas.openxmlformats.org/officeDocument/2006/relationships/image" Target="../media/image13.png"/><Relationship Id="rId10" Type="http://schemas.openxmlformats.org/officeDocument/2006/relationships/image" Target="../media/image8.tmp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8861145D-EB26-4CCE-149B-E1BEB7C639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614" t="19520" r="15995" b="7617"/>
          <a:stretch/>
        </p:blipFill>
        <p:spPr>
          <a:xfrm>
            <a:off x="6132481" y="596705"/>
            <a:ext cx="1123613" cy="1054553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73CFA32D-839C-F421-CC8E-33B0CAFFC2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7099" y="1940063"/>
            <a:ext cx="3353091" cy="3299390"/>
          </a:xfrm>
          <a:prstGeom prst="rect">
            <a:avLst/>
          </a:prstGeom>
        </p:spPr>
      </p:pic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21824076-300F-ABA9-E0C9-20E0639BB353}"/>
              </a:ext>
            </a:extLst>
          </p:cNvPr>
          <p:cNvCxnSpPr>
            <a:cxnSpLocks/>
          </p:cNvCxnSpPr>
          <p:nvPr/>
        </p:nvCxnSpPr>
        <p:spPr>
          <a:xfrm flipV="1">
            <a:off x="5527074" y="1730610"/>
            <a:ext cx="529777" cy="10050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9C80B024-285E-FA18-9954-EA4F5C683378}"/>
              </a:ext>
            </a:extLst>
          </p:cNvPr>
          <p:cNvCxnSpPr>
            <a:cxnSpLocks/>
          </p:cNvCxnSpPr>
          <p:nvPr/>
        </p:nvCxnSpPr>
        <p:spPr>
          <a:xfrm flipV="1">
            <a:off x="5637529" y="1747117"/>
            <a:ext cx="1837062" cy="108073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Imagen 13" descr="Interfaz de usuario gráfica, Aplicación, Word&#10;&#10;Descripción generada automáticamente">
            <a:extLst>
              <a:ext uri="{FF2B5EF4-FFF2-40B4-BE49-F238E27FC236}">
                <a16:creationId xmlns:a16="http://schemas.microsoft.com/office/drawing/2014/main" id="{6AF621D5-F621-C485-A326-71535B16BF4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43" t="46121" r="53142" b="25370"/>
          <a:stretch/>
        </p:blipFill>
        <p:spPr>
          <a:xfrm>
            <a:off x="7885653" y="374097"/>
            <a:ext cx="4027421" cy="2453754"/>
          </a:xfrm>
          <a:prstGeom prst="rect">
            <a:avLst/>
          </a:prstGeom>
        </p:spPr>
      </p:pic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33C87423-738D-C5E8-A7A5-0B592D0C0F0F}"/>
              </a:ext>
            </a:extLst>
          </p:cNvPr>
          <p:cNvCxnSpPr>
            <a:cxnSpLocks/>
          </p:cNvCxnSpPr>
          <p:nvPr/>
        </p:nvCxnSpPr>
        <p:spPr>
          <a:xfrm flipV="1">
            <a:off x="3003259" y="4643123"/>
            <a:ext cx="1544972" cy="3645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98ED3BCA-BF76-F87E-6DA7-2AC295C6B250}"/>
              </a:ext>
            </a:extLst>
          </p:cNvPr>
          <p:cNvCxnSpPr>
            <a:cxnSpLocks/>
          </p:cNvCxnSpPr>
          <p:nvPr/>
        </p:nvCxnSpPr>
        <p:spPr>
          <a:xfrm flipH="1" flipV="1">
            <a:off x="5019414" y="4784828"/>
            <a:ext cx="290818" cy="10896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Imagen 19" descr="Interfaz de usuario gráfica, Texto, Aplicación, Word&#10;&#10;Descripción generada automáticamente">
            <a:extLst>
              <a:ext uri="{FF2B5EF4-FFF2-40B4-BE49-F238E27FC236}">
                <a16:creationId xmlns:a16="http://schemas.microsoft.com/office/drawing/2014/main" id="{58E42824-0B96-5B08-4B17-992E5843E8A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06" t="53863" r="56238" b="31123"/>
          <a:stretch/>
        </p:blipFill>
        <p:spPr>
          <a:xfrm>
            <a:off x="5922629" y="5351586"/>
            <a:ext cx="3519967" cy="1280305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id="{24E1081F-E170-BCB1-550E-2551CEB57DB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5955" t="20664" r="8344" b="5618"/>
          <a:stretch/>
        </p:blipFill>
        <p:spPr>
          <a:xfrm>
            <a:off x="4387442" y="5671946"/>
            <a:ext cx="1120058" cy="1073246"/>
          </a:xfrm>
          <a:prstGeom prst="rect">
            <a:avLst/>
          </a:prstGeom>
        </p:spPr>
      </p:pic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12EA6895-798D-1266-2213-BFEBF829C2AF}"/>
              </a:ext>
            </a:extLst>
          </p:cNvPr>
          <p:cNvCxnSpPr>
            <a:cxnSpLocks/>
          </p:cNvCxnSpPr>
          <p:nvPr/>
        </p:nvCxnSpPr>
        <p:spPr>
          <a:xfrm flipV="1">
            <a:off x="4387441" y="4908646"/>
            <a:ext cx="573248" cy="9823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id="{7BA8D2AB-5C21-6DB0-C8FD-FC5145EC1417}"/>
              </a:ext>
            </a:extLst>
          </p:cNvPr>
          <p:cNvCxnSpPr>
            <a:cxnSpLocks/>
          </p:cNvCxnSpPr>
          <p:nvPr/>
        </p:nvCxnSpPr>
        <p:spPr>
          <a:xfrm flipV="1">
            <a:off x="3548543" y="4735300"/>
            <a:ext cx="1219200" cy="113913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Imagen 27" descr="Interfaz de usuario gráfica, Aplicación&#10;&#10;Descripción generada automáticamente">
            <a:extLst>
              <a:ext uri="{FF2B5EF4-FFF2-40B4-BE49-F238E27FC236}">
                <a16:creationId xmlns:a16="http://schemas.microsoft.com/office/drawing/2014/main" id="{AD85419D-ECB8-CD9F-8B74-1B1AE4772E1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12" t="50284" r="56170" b="29028"/>
          <a:stretch/>
        </p:blipFill>
        <p:spPr>
          <a:xfrm>
            <a:off x="21787" y="5102052"/>
            <a:ext cx="3258307" cy="1643139"/>
          </a:xfrm>
          <a:prstGeom prst="rect">
            <a:avLst/>
          </a:prstGeom>
        </p:spPr>
      </p:pic>
      <p:pic>
        <p:nvPicPr>
          <p:cNvPr id="32" name="Imagen 31">
            <a:extLst>
              <a:ext uri="{FF2B5EF4-FFF2-40B4-BE49-F238E27FC236}">
                <a16:creationId xmlns:a16="http://schemas.microsoft.com/office/drawing/2014/main" id="{EF1E4F0A-C907-EA2E-C5EE-4936CBF9DFF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8300" t="14517" r="10245" b="6544"/>
          <a:stretch/>
        </p:blipFill>
        <p:spPr>
          <a:xfrm>
            <a:off x="2196179" y="3480592"/>
            <a:ext cx="986828" cy="941029"/>
          </a:xfrm>
          <a:prstGeom prst="rect">
            <a:avLst/>
          </a:prstGeom>
        </p:spPr>
      </p:pic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80957053-3899-0B9E-D4FA-91482062FF94}"/>
              </a:ext>
            </a:extLst>
          </p:cNvPr>
          <p:cNvCxnSpPr>
            <a:cxnSpLocks/>
          </p:cNvCxnSpPr>
          <p:nvPr/>
        </p:nvCxnSpPr>
        <p:spPr>
          <a:xfrm>
            <a:off x="3296873" y="3480593"/>
            <a:ext cx="1059809" cy="9905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7788E5B3-58CE-BE52-13F1-0D828541326F}"/>
              </a:ext>
            </a:extLst>
          </p:cNvPr>
          <p:cNvCxnSpPr>
            <a:cxnSpLocks/>
          </p:cNvCxnSpPr>
          <p:nvPr/>
        </p:nvCxnSpPr>
        <p:spPr>
          <a:xfrm>
            <a:off x="3280095" y="4421620"/>
            <a:ext cx="1237376" cy="19948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Imagen 40" descr="Interfaz de usuario gráfica, Aplicación&#10;&#10;Descripción generada automáticamente">
            <a:extLst>
              <a:ext uri="{FF2B5EF4-FFF2-40B4-BE49-F238E27FC236}">
                <a16:creationId xmlns:a16="http://schemas.microsoft.com/office/drawing/2014/main" id="{1D08161B-3EA6-3E2E-608C-939827246A4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39" t="51045" r="61331" b="30794"/>
          <a:stretch/>
        </p:blipFill>
        <p:spPr>
          <a:xfrm>
            <a:off x="0" y="3291034"/>
            <a:ext cx="2331624" cy="1522215"/>
          </a:xfrm>
          <a:prstGeom prst="rect">
            <a:avLst/>
          </a:prstGeom>
        </p:spPr>
      </p:pic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id="{292ED528-A06D-0E4A-B080-36EBF4D72489}"/>
              </a:ext>
            </a:extLst>
          </p:cNvPr>
          <p:cNvCxnSpPr>
            <a:cxnSpLocks/>
          </p:cNvCxnSpPr>
          <p:nvPr/>
        </p:nvCxnSpPr>
        <p:spPr>
          <a:xfrm>
            <a:off x="3338818" y="2762438"/>
            <a:ext cx="687898" cy="66862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54">
            <a:extLst>
              <a:ext uri="{FF2B5EF4-FFF2-40B4-BE49-F238E27FC236}">
                <a16:creationId xmlns:a16="http://schemas.microsoft.com/office/drawing/2014/main" id="{6B80F4BD-6825-1C72-F720-1882E1932041}"/>
              </a:ext>
            </a:extLst>
          </p:cNvPr>
          <p:cNvCxnSpPr>
            <a:cxnSpLocks/>
          </p:cNvCxnSpPr>
          <p:nvPr/>
        </p:nvCxnSpPr>
        <p:spPr>
          <a:xfrm>
            <a:off x="3313651" y="1788392"/>
            <a:ext cx="753612" cy="159727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Imagen 60" descr="Interfaz de usuario gráfica, Aplicación, Word&#10;&#10;Descripción generada automáticamente">
            <a:extLst>
              <a:ext uri="{FF2B5EF4-FFF2-40B4-BE49-F238E27FC236}">
                <a16:creationId xmlns:a16="http://schemas.microsoft.com/office/drawing/2014/main" id="{2DB90042-FD89-9DAC-9DAC-B02595418B9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92" t="53564" r="60436" b="33569"/>
          <a:stretch/>
        </p:blipFill>
        <p:spPr>
          <a:xfrm>
            <a:off x="147379" y="1761502"/>
            <a:ext cx="2821916" cy="1197639"/>
          </a:xfrm>
          <a:prstGeom prst="rect">
            <a:avLst/>
          </a:prstGeom>
        </p:spPr>
      </p:pic>
      <p:pic>
        <p:nvPicPr>
          <p:cNvPr id="64" name="Imagen 63">
            <a:extLst>
              <a:ext uri="{FF2B5EF4-FFF2-40B4-BE49-F238E27FC236}">
                <a16:creationId xmlns:a16="http://schemas.microsoft.com/office/drawing/2014/main" id="{1938F811-952D-7F98-64F0-730903CCA7EC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5984" t="20957" r="12031" b="5405"/>
          <a:stretch/>
        </p:blipFill>
        <p:spPr>
          <a:xfrm>
            <a:off x="7556011" y="3741980"/>
            <a:ext cx="986829" cy="993320"/>
          </a:xfrm>
          <a:prstGeom prst="rect">
            <a:avLst/>
          </a:prstGeom>
        </p:spPr>
      </p:pic>
      <p:cxnSp>
        <p:nvCxnSpPr>
          <p:cNvPr id="65" name="Conector recto 64">
            <a:extLst>
              <a:ext uri="{FF2B5EF4-FFF2-40B4-BE49-F238E27FC236}">
                <a16:creationId xmlns:a16="http://schemas.microsoft.com/office/drawing/2014/main" id="{9EE2E31B-7507-0F42-C016-C3130CD655C6}"/>
              </a:ext>
            </a:extLst>
          </p:cNvPr>
          <p:cNvCxnSpPr>
            <a:cxnSpLocks/>
          </p:cNvCxnSpPr>
          <p:nvPr/>
        </p:nvCxnSpPr>
        <p:spPr>
          <a:xfrm flipV="1">
            <a:off x="6132481" y="3629175"/>
            <a:ext cx="1241443" cy="304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66">
            <a:extLst>
              <a:ext uri="{FF2B5EF4-FFF2-40B4-BE49-F238E27FC236}">
                <a16:creationId xmlns:a16="http://schemas.microsoft.com/office/drawing/2014/main" id="{88F1ABE4-DDDC-2602-9219-0632F48A96BE}"/>
              </a:ext>
            </a:extLst>
          </p:cNvPr>
          <p:cNvCxnSpPr>
            <a:cxnSpLocks/>
          </p:cNvCxnSpPr>
          <p:nvPr/>
        </p:nvCxnSpPr>
        <p:spPr>
          <a:xfrm>
            <a:off x="6075157" y="4133461"/>
            <a:ext cx="1273600" cy="63485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Imagen 70" descr="Interfaz de usuario gráfica, Aplicación, Word&#10;&#10;Descripción generada automáticamente">
            <a:extLst>
              <a:ext uri="{FF2B5EF4-FFF2-40B4-BE49-F238E27FC236}">
                <a16:creationId xmlns:a16="http://schemas.microsoft.com/office/drawing/2014/main" id="{942218CF-5ED4-E65E-B1B9-B80ABA44C31E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18" t="54951" r="57619" b="33569"/>
          <a:stretch/>
        </p:blipFill>
        <p:spPr>
          <a:xfrm>
            <a:off x="8473591" y="3766621"/>
            <a:ext cx="3568299" cy="1079707"/>
          </a:xfrm>
          <a:prstGeom prst="rect">
            <a:avLst/>
          </a:prstGeom>
        </p:spPr>
      </p:pic>
      <p:pic>
        <p:nvPicPr>
          <p:cNvPr id="72" name="Imagen 71">
            <a:extLst>
              <a:ext uri="{FF2B5EF4-FFF2-40B4-BE49-F238E27FC236}">
                <a16:creationId xmlns:a16="http://schemas.microsoft.com/office/drawing/2014/main" id="{4003B6AC-25D7-E41C-5C46-89D5F05B3B0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918" t="21059" r="12437" b="3302"/>
          <a:stretch/>
        </p:blipFill>
        <p:spPr>
          <a:xfrm>
            <a:off x="2331625" y="1940062"/>
            <a:ext cx="851382" cy="795614"/>
          </a:xfrm>
          <a:prstGeom prst="rect">
            <a:avLst/>
          </a:prstGeom>
        </p:spPr>
      </p:pic>
      <p:sp>
        <p:nvSpPr>
          <p:cNvPr id="73" name="CuadroTexto 72">
            <a:extLst>
              <a:ext uri="{FF2B5EF4-FFF2-40B4-BE49-F238E27FC236}">
                <a16:creationId xmlns:a16="http://schemas.microsoft.com/office/drawing/2014/main" id="{42BC2C47-1E4E-34A9-4960-4EA003EB7572}"/>
              </a:ext>
            </a:extLst>
          </p:cNvPr>
          <p:cNvSpPr txBox="1"/>
          <p:nvPr/>
        </p:nvSpPr>
        <p:spPr>
          <a:xfrm>
            <a:off x="147380" y="1475230"/>
            <a:ext cx="1688548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Parkinson’s</a:t>
            </a:r>
            <a:r>
              <a:rPr lang="es-ES" sz="1378" b="1" dirty="0"/>
              <a:t> </a:t>
            </a:r>
            <a:r>
              <a:rPr lang="es-ES" sz="1378" b="1" dirty="0" err="1"/>
              <a:t>disease</a:t>
            </a:r>
            <a:endParaRPr lang="es-ES" sz="1378" b="1" dirty="0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72928B11-B4F7-721D-DA13-B473327C9901}"/>
              </a:ext>
            </a:extLst>
          </p:cNvPr>
          <p:cNvSpPr txBox="1"/>
          <p:nvPr/>
        </p:nvSpPr>
        <p:spPr>
          <a:xfrm>
            <a:off x="438781" y="2988186"/>
            <a:ext cx="1215850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Integrins</a:t>
            </a:r>
            <a:endParaRPr lang="es-ES" sz="1378" b="1" dirty="0"/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B0CC47BA-7ED3-713A-F1C8-B32F0264042C}"/>
              </a:ext>
            </a:extLst>
          </p:cNvPr>
          <p:cNvSpPr txBox="1"/>
          <p:nvPr/>
        </p:nvSpPr>
        <p:spPr>
          <a:xfrm>
            <a:off x="226064" y="4856276"/>
            <a:ext cx="1215850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Inflammation</a:t>
            </a:r>
            <a:endParaRPr lang="es-ES" sz="1378" b="1" dirty="0"/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CE011F77-C76E-261A-F4DB-3791C295196B}"/>
              </a:ext>
            </a:extLst>
          </p:cNvPr>
          <p:cNvSpPr txBox="1"/>
          <p:nvPr/>
        </p:nvSpPr>
        <p:spPr>
          <a:xfrm>
            <a:off x="6841895" y="5048738"/>
            <a:ext cx="1981200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Huntington’s</a:t>
            </a:r>
            <a:r>
              <a:rPr lang="es-ES" sz="1378" b="1" dirty="0"/>
              <a:t> </a:t>
            </a:r>
            <a:r>
              <a:rPr lang="es-ES" sz="1378" b="1" dirty="0" err="1"/>
              <a:t>disease</a:t>
            </a:r>
            <a:endParaRPr lang="es-ES" sz="1378" b="1" dirty="0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57F550D6-832E-D286-47CF-7623B5FBE18C}"/>
              </a:ext>
            </a:extLst>
          </p:cNvPr>
          <p:cNvSpPr txBox="1"/>
          <p:nvPr/>
        </p:nvSpPr>
        <p:spPr>
          <a:xfrm>
            <a:off x="9156357" y="3439133"/>
            <a:ext cx="1981200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Dopamine</a:t>
            </a:r>
            <a:r>
              <a:rPr lang="es-ES" sz="1378" b="1" dirty="0"/>
              <a:t> receptor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B3BD3DDC-7D1F-9DE5-28B4-34399ED0E8EA}"/>
              </a:ext>
            </a:extLst>
          </p:cNvPr>
          <p:cNvSpPr txBox="1"/>
          <p:nvPr/>
        </p:nvSpPr>
        <p:spPr>
          <a:xfrm>
            <a:off x="8064843" y="103555"/>
            <a:ext cx="1981200" cy="3028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378" b="1" dirty="0" err="1"/>
              <a:t>Alzheimer’s</a:t>
            </a:r>
            <a:r>
              <a:rPr lang="es-ES" sz="1378" b="1" dirty="0"/>
              <a:t> </a:t>
            </a:r>
            <a:r>
              <a:rPr lang="es-ES" sz="1378" b="1" dirty="0" err="1"/>
              <a:t>disease</a:t>
            </a:r>
            <a:endParaRPr lang="es-ES" sz="1378" b="1" dirty="0"/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AEE2385F-1453-1A3A-4A2C-B1D4E5E8ECAA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11233" t="21785" r="14280" b="9197"/>
          <a:stretch/>
        </p:blipFill>
        <p:spPr>
          <a:xfrm>
            <a:off x="2650892" y="5023943"/>
            <a:ext cx="1043328" cy="951236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804C15F3-4B71-F88E-D2CB-293DC1905FC0}"/>
              </a:ext>
            </a:extLst>
          </p:cNvPr>
          <p:cNvSpPr txBox="1"/>
          <p:nvPr/>
        </p:nvSpPr>
        <p:spPr>
          <a:xfrm>
            <a:off x="74080" y="151495"/>
            <a:ext cx="6001076" cy="10448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86" b="1" dirty="0">
                <a:latin typeface="Palatino Linotype" panose="02040502050505030304" pitchFamily="18" charset="0"/>
              </a:rPr>
              <a:t>Supplementary Figure S2. </a:t>
            </a:r>
            <a:r>
              <a:rPr lang="en-US" sz="886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eurodegenerative disease-associated pathways regulated by the proteins identified in </a:t>
            </a:r>
            <a:r>
              <a:rPr lang="en-US" sz="886" b="1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osustrophine</a:t>
            </a:r>
            <a:r>
              <a:rPr lang="en-US" sz="886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886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sustrophine</a:t>
            </a:r>
            <a:r>
              <a:rPr lang="en-US" sz="886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tracts (1 mg) were mixed with tagged peptides before being fractionated and separated using nano-flow LC-coupled to a high-resolution trapped ion mobility spectrometry (TIMS) on a quadrupole TOF (Q-TOF). This was followed by bioinformatic analysis with the PANTHER Classification System. The proteins found in </a:t>
            </a:r>
            <a:r>
              <a:rPr lang="en-US" sz="886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sustrophine</a:t>
            </a:r>
            <a:r>
              <a:rPr lang="en-US" sz="886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trol numerous neurodegenerative disease pathways such as Huntington's disease, Alzheimer's disease, Parkinson's disease, dopamine receptor, inflammation, and integrins. The main proteins detected within each pathway are shown.</a:t>
            </a:r>
            <a:endParaRPr lang="es-ES" sz="886" b="1" dirty="0"/>
          </a:p>
        </p:txBody>
      </p:sp>
    </p:spTree>
    <p:extLst>
      <p:ext uri="{BB962C8B-B14F-4D97-AF65-F5344CB8AC3E}">
        <p14:creationId xmlns:p14="http://schemas.microsoft.com/office/powerpoint/2010/main" val="14473523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pigenetica</dc:creator>
  <cp:lastModifiedBy>MDPI</cp:lastModifiedBy>
  <cp:revision>3</cp:revision>
  <dcterms:created xsi:type="dcterms:W3CDTF">2022-10-13T07:13:55Z</dcterms:created>
  <dcterms:modified xsi:type="dcterms:W3CDTF">2022-11-12T05:22:09Z</dcterms:modified>
</cp:coreProperties>
</file>